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1" r:id="rId4"/>
    <p:sldId id="260" r:id="rId5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ee Yen Lin" initials="" lastIdx="2" clrIdx="0"/>
  <p:cmAuthor id="1" name="GOH PIK WEI" initials="GPW" lastIdx="12" clrIdx="1">
    <p:extLst>
      <p:ext uri="{19B8F6BF-5375-455C-9EA6-DF929625EA0E}">
        <p15:presenceInfo xmlns:p15="http://schemas.microsoft.com/office/powerpoint/2012/main" userId="S-1-5-21-154280456-1944677375-1177442754-152443" providerId="AD"/>
      </p:ext>
    </p:extLst>
  </p:cmAuthor>
  <p:cmAuthor id="2" name="Xue Jing Chong" initials="XJC" lastIdx="12" clrIdx="2">
    <p:extLst>
      <p:ext uri="{19B8F6BF-5375-455C-9EA6-DF929625EA0E}">
        <p15:presenceInfo xmlns:p15="http://schemas.microsoft.com/office/powerpoint/2012/main" userId="Xue Jing Chong" providerId="None"/>
      </p:ext>
    </p:extLst>
  </p:cmAuthor>
  <p:cmAuthor id="3" name="Chong Xue Jing" initials="CXJ" lastIdx="6" clrIdx="3">
    <p:extLst>
      <p:ext uri="{19B8F6BF-5375-455C-9EA6-DF929625EA0E}">
        <p15:presenceInfo xmlns:p15="http://schemas.microsoft.com/office/powerpoint/2012/main" userId="S-1-5-21-154280456-1944677375-1177442754-210991" providerId="AD"/>
      </p:ext>
    </p:extLst>
  </p:cmAuthor>
  <p:cmAuthor id="4" name="Yap Eng Soo" initials="YES" lastIdx="2" clrIdx="4">
    <p:extLst>
      <p:ext uri="{19B8F6BF-5375-455C-9EA6-DF929625EA0E}">
        <p15:presenceInfo xmlns:p15="http://schemas.microsoft.com/office/powerpoint/2012/main" userId="S-1-5-21-154280456-1944677375-1177442754-2124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FF"/>
    <a:srgbClr val="FFFF99"/>
    <a:srgbClr val="33CCCC"/>
    <a:srgbClr val="9999FF"/>
    <a:srgbClr val="3399FF"/>
    <a:srgbClr val="6666FF"/>
    <a:srgbClr val="FFFFCC"/>
    <a:srgbClr val="FFFFFF"/>
    <a:srgbClr val="FFCC99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FD4443E-F989-4FC4-A0C8-D5A2AF1F390B}" styleName="Dark Style 1 - Accent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89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732" y="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9642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949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8565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3929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90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212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787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0965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898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6298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9738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EB45F-37E0-41A7-8BCE-598BC4DAC56F}" type="datetimeFigureOut">
              <a:rPr lang="en-GB" smtClean="0"/>
              <a:t>15/03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C509E-0C31-4796-A967-CB28B79487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274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1205" y="256804"/>
            <a:ext cx="5744996" cy="316875"/>
          </a:xfrm>
        </p:spPr>
        <p:txBody>
          <a:bodyPr>
            <a:noAutofit/>
          </a:bodyPr>
          <a:lstStyle/>
          <a:p>
            <a:pPr algn="l"/>
            <a:r>
              <a:rPr lang="en-US" sz="1600" b="1" dirty="0">
                <a:latin typeface="+mn-lt"/>
              </a:rPr>
              <a:t>Peri‐operative management of anticoagulation and</a:t>
            </a:r>
            <a:br>
              <a:rPr lang="en-US" sz="1600" b="1" dirty="0">
                <a:latin typeface="+mn-lt"/>
              </a:rPr>
            </a:br>
            <a:r>
              <a:rPr lang="en-US" sz="1600" b="1" dirty="0">
                <a:latin typeface="+mn-lt"/>
              </a:rPr>
              <a:t>antiplatelet therapy</a:t>
            </a:r>
          </a:p>
        </p:txBody>
      </p:sp>
      <p:sp>
        <p:nvSpPr>
          <p:cNvPr id="4" name="Rectangle 9"/>
          <p:cNvSpPr>
            <a:spLocks noChangeArrowheads="1"/>
          </p:cNvSpPr>
          <p:nvPr/>
        </p:nvSpPr>
        <p:spPr bwMode="auto">
          <a:xfrm>
            <a:off x="6012264" y="97795"/>
            <a:ext cx="845736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                                                           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Rectangle 10"/>
          <p:cNvSpPr>
            <a:spLocks noChangeArrowheads="1"/>
          </p:cNvSpPr>
          <p:nvPr/>
        </p:nvSpPr>
        <p:spPr bwMode="auto">
          <a:xfrm>
            <a:off x="51464" y="578642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12"/>
          <p:cNvSpPr>
            <a:spLocks noChangeArrowheads="1"/>
          </p:cNvSpPr>
          <p:nvPr/>
        </p:nvSpPr>
        <p:spPr bwMode="auto">
          <a:xfrm>
            <a:off x="0" y="834263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13"/>
          <p:cNvSpPr>
            <a:spLocks noChangeArrowheads="1"/>
          </p:cNvSpPr>
          <p:nvPr/>
        </p:nvSpPr>
        <p:spPr bwMode="auto">
          <a:xfrm>
            <a:off x="0" y="855885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14"/>
          <p:cNvSpPr>
            <a:spLocks noChangeArrowheads="1"/>
          </p:cNvSpPr>
          <p:nvPr/>
        </p:nvSpPr>
        <p:spPr bwMode="auto">
          <a:xfrm>
            <a:off x="55842" y="80588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49727" y="640296"/>
            <a:ext cx="6358546" cy="769441"/>
          </a:xfrm>
          <a:prstGeom prst="rect">
            <a:avLst/>
          </a:prstGeom>
          <a:solidFill>
            <a:schemeClr val="accent1">
              <a:lumMod val="75000"/>
              <a:alpha val="1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90488" indent="-90488" fontAlgn="t">
              <a:buFont typeface="Arial" panose="020B0604020202020204" pitchFamily="34" charset="0"/>
              <a:buChar char="•"/>
            </a:pPr>
            <a:r>
              <a:rPr lang="en-US" sz="1100" dirty="0"/>
              <a:t>Depending on the invasiveness of the procedures or surgery, patients taking anticoagulation or antiplatelet therapy may require interruption of anticoagulation or antiplatelet</a:t>
            </a:r>
          </a:p>
          <a:p>
            <a:pPr marL="90488" indent="-90488" fontAlgn="t">
              <a:buFont typeface="Arial" panose="020B0604020202020204" pitchFamily="34" charset="0"/>
              <a:buChar char="•"/>
            </a:pPr>
            <a:r>
              <a:rPr lang="en-US" sz="1100" dirty="0"/>
              <a:t>During interruption of anticoagulation, depending on the thromboembolic risk, bridging treatment with shorter acting anticoagulation may sometimes be required.</a:t>
            </a:r>
          </a:p>
        </p:txBody>
      </p: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3914814"/>
              </p:ext>
            </p:extLst>
          </p:nvPr>
        </p:nvGraphicFramePr>
        <p:xfrm>
          <a:off x="249727" y="1471390"/>
          <a:ext cx="6358546" cy="3474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31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613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4409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r>
                        <a:rPr lang="en-US" sz="1050" dirty="0"/>
                        <a:t>Table</a:t>
                      </a:r>
                      <a:r>
                        <a:rPr lang="en-US" sz="1050" baseline="0" dirty="0"/>
                        <a:t> 1. </a:t>
                      </a:r>
                      <a:r>
                        <a:rPr lang="en-GB" sz="1050" dirty="0"/>
                        <a:t>Suggested Risk Stratification for Procedural Bleed Risk Based on ISTH Guidance Statements</a:t>
                      </a:r>
                      <a:endParaRPr lang="en-US" sz="105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5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3366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336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3537"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Minimal bleeding risk procedure* </a:t>
                      </a:r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Low bleeding risk procedure*</a:t>
                      </a:r>
                    </a:p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en-GB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30-d risk of major bleed 0%-2%)</a:t>
                      </a:r>
                      <a:endParaRPr lang="en-US" sz="105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High bleeding risk procedure *</a:t>
                      </a:r>
                    </a:p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en-GB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30-d risk of major bleed  ≥2%)</a:t>
                      </a:r>
                      <a:endParaRPr lang="en-US" sz="105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2922">
                <a:tc>
                  <a:txBody>
                    <a:bodyPr/>
                    <a:lstStyle/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Skin</a:t>
                      </a:r>
                      <a:r>
                        <a:rPr lang="en-US" sz="1050" baseline="0" dirty="0"/>
                        <a:t> excisional biopsy</a:t>
                      </a:r>
                      <a:endParaRPr lang="en-US" sz="1050" dirty="0"/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Cataract</a:t>
                      </a:r>
                      <a:r>
                        <a:rPr lang="en-US" sz="1050" baseline="0" dirty="0"/>
                        <a:t> surgery</a:t>
                      </a:r>
                      <a:endParaRPr lang="en-US" sz="1050" dirty="0"/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Minor dental procedures i.e.</a:t>
                      </a:r>
                      <a:r>
                        <a:rPr lang="en-US" sz="1050" baseline="0" dirty="0"/>
                        <a:t> simple </a:t>
                      </a:r>
                      <a:r>
                        <a:rPr lang="en-US" sz="1050" dirty="0"/>
                        <a:t>extractions, prosthetics, endodontics,</a:t>
                      </a:r>
                      <a:r>
                        <a:rPr lang="en-US" sz="1050" baseline="0" dirty="0"/>
                        <a:t> filling, scaling &amp; polishing</a:t>
                      </a:r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baseline="0" dirty="0"/>
                        <a:t>PPM or ICD installation</a:t>
                      </a:r>
                      <a:endParaRPr lang="en-US" sz="105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Arthroscopy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Bladder,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ostate,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hyroid,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breast,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 and </a:t>
                      </a: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lymph node biopsies</a:t>
                      </a:r>
                    </a:p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Pct val="100000"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holecystectomy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bdominal hysterectomy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or </a:t>
                      </a:r>
                      <a:r>
                        <a:rPr lang="en-US" sz="105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ernioraphy</a:t>
                      </a:r>
                      <a:endParaRPr lang="en-US" sz="105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Haemorrhoidal</a:t>
                      </a: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surgery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ilatation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and curettage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Bronchoscopy +/- biopsy</a:t>
                      </a:r>
                    </a:p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Pct val="100000"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Endoscopy </a:t>
                      </a:r>
                      <a:r>
                        <a:rPr lang="en-US" sz="1050" dirty="0"/>
                        <a:t>+/- biopsy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Coronary angiography</a:t>
                      </a:r>
                      <a:endParaRPr lang="en-US" sz="105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baseline="0" dirty="0"/>
                        <a:t>TKR or THR</a:t>
                      </a:r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baseline="0" dirty="0"/>
                        <a:t>Laminectomy</a:t>
                      </a:r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baseline="0" dirty="0"/>
                        <a:t>Foot, hand and shoulder surgery</a:t>
                      </a:r>
                      <a:endParaRPr lang="en-US" sz="1050" dirty="0"/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Cancer surgery</a:t>
                      </a:r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CABG</a:t>
                      </a:r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Heart valve</a:t>
                      </a:r>
                      <a:r>
                        <a:rPr lang="en-US" sz="1050" baseline="0" dirty="0"/>
                        <a:t> surgery</a:t>
                      </a:r>
                      <a:endParaRPr lang="en-US" sz="1050" dirty="0"/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Vascular</a:t>
                      </a:r>
                      <a:r>
                        <a:rPr lang="en-US" sz="1050" baseline="0" dirty="0"/>
                        <a:t> surgery</a:t>
                      </a:r>
                    </a:p>
                    <a:p>
                      <a:pPr marL="171450" lvl="0" indent="-171450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baseline="0" dirty="0"/>
                        <a:t>Kidney biopsy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olypectomy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EG insertion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ERCP + </a:t>
                      </a:r>
                      <a:r>
                        <a:rPr lang="en-US" sz="1050" kern="120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sphincterectomy</a:t>
                      </a:r>
                      <a:endParaRPr lang="en-US" sz="105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URP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ny major 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peration of duration &gt;45 minutes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Neuraxial anesthesia (will need anesthetist’s inputs)</a:t>
                      </a:r>
                    </a:p>
                    <a:p>
                      <a:pPr marL="171450" lvl="0" indent="-171450" algn="l" defTabSz="685800" rtl="0" eaLnBrk="1" latinLnBrk="0" hangingPunct="1">
                        <a:buSzPct val="100000"/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Epidural injections</a:t>
                      </a: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31" name="Table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9276421"/>
              </p:ext>
            </p:extLst>
          </p:nvPr>
        </p:nvGraphicFramePr>
        <p:xfrm>
          <a:off x="249728" y="4975596"/>
          <a:ext cx="6358545" cy="47777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83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74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0194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5079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3825">
                <a:tc gridSpan="4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Table 2. Risk of thromboembolic</a:t>
                      </a:r>
                      <a:r>
                        <a:rPr lang="en-US" sz="1050" b="1" kern="1200" baseline="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 risk</a:t>
                      </a:r>
                      <a:endParaRPr lang="en-US" sz="1050" b="1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5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80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33669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3366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050" b="0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kern="1200" dirty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Low</a:t>
                      </a:r>
                      <a:r>
                        <a:rPr lang="en-GB" sz="1050" dirty="0">
                          <a:solidFill>
                            <a:schemeClr val="bg1"/>
                          </a:solidFill>
                        </a:rPr>
                        <a:t> (&lt; 4%/y risk of ATE or &lt; 2%/</a:t>
                      </a:r>
                      <a:r>
                        <a:rPr lang="en-GB" sz="1050" dirty="0" err="1">
                          <a:solidFill>
                            <a:schemeClr val="bg1"/>
                          </a:solidFill>
                        </a:rPr>
                        <a:t>mo</a:t>
                      </a:r>
                      <a:r>
                        <a:rPr lang="en-GB" sz="1050" dirty="0">
                          <a:solidFill>
                            <a:schemeClr val="bg1"/>
                          </a:solidFill>
                        </a:rPr>
                        <a:t> risk of VTE)</a:t>
                      </a:r>
                      <a:endParaRPr lang="en-US" sz="1050" b="0" kern="1200" dirty="0">
                        <a:solidFill>
                          <a:schemeClr val="bg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kern="1200" dirty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Moderate</a:t>
                      </a:r>
                      <a:r>
                        <a:rPr lang="en-US" sz="1050" b="0" kern="1200" dirty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GB" sz="1050" dirty="0">
                          <a:solidFill>
                            <a:schemeClr val="bg1"/>
                          </a:solidFill>
                        </a:rPr>
                        <a:t>(4%-10%/y risk of ATE or 4%-10%/</a:t>
                      </a:r>
                      <a:r>
                        <a:rPr lang="en-GB" sz="1050" dirty="0" err="1">
                          <a:solidFill>
                            <a:schemeClr val="bg1"/>
                          </a:solidFill>
                        </a:rPr>
                        <a:t>mo</a:t>
                      </a:r>
                      <a:r>
                        <a:rPr lang="en-GB" sz="1050" dirty="0">
                          <a:solidFill>
                            <a:schemeClr val="bg1"/>
                          </a:solidFill>
                        </a:rPr>
                        <a:t> risk of VTE)</a:t>
                      </a:r>
                      <a:endParaRPr lang="en-US" sz="1050" b="0" kern="1200" dirty="0">
                        <a:solidFill>
                          <a:schemeClr val="bg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1" kern="1200" dirty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High</a:t>
                      </a:r>
                      <a:r>
                        <a:rPr lang="en-US" sz="1050" b="0" kern="1200" dirty="0">
                          <a:solidFill>
                            <a:schemeClr val="bg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GB" sz="1050" dirty="0">
                          <a:solidFill>
                            <a:schemeClr val="bg1"/>
                          </a:solidFill>
                        </a:rPr>
                        <a:t>(&gt; 10%/y risk of ATE or &gt; 10%/</a:t>
                      </a:r>
                      <a:r>
                        <a:rPr lang="en-GB" sz="1050" dirty="0" err="1">
                          <a:solidFill>
                            <a:schemeClr val="bg1"/>
                          </a:solidFill>
                        </a:rPr>
                        <a:t>mo</a:t>
                      </a:r>
                      <a:r>
                        <a:rPr lang="en-GB" sz="1050" dirty="0">
                          <a:solidFill>
                            <a:schemeClr val="bg1"/>
                          </a:solidFill>
                        </a:rPr>
                        <a:t> risk of VTE)</a:t>
                      </a:r>
                      <a:endParaRPr lang="en-US" sz="1050" b="0" kern="1200" dirty="0">
                        <a:solidFill>
                          <a:schemeClr val="bg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09375"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50" dirty="0"/>
                        <a:t>Heart</a:t>
                      </a:r>
                      <a:r>
                        <a:rPr lang="en-US" sz="1050" baseline="0" dirty="0"/>
                        <a:t> Valves</a:t>
                      </a: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50" dirty="0"/>
                        <a:t>Bi-leaflet</a:t>
                      </a:r>
                      <a:r>
                        <a:rPr lang="en-US" sz="1050" baseline="0" dirty="0"/>
                        <a:t> </a:t>
                      </a:r>
                      <a:r>
                        <a:rPr lang="en-US" sz="1050" dirty="0"/>
                        <a:t>AVR without major risk factors 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050" dirty="0"/>
                        <a:t>Bi-leaflet AVR with major risk factors</a:t>
                      </a:r>
                      <a:r>
                        <a:rPr lang="en-US" sz="1050" baseline="0" dirty="0"/>
                        <a:t> (1 or more of the following)</a:t>
                      </a:r>
                    </a:p>
                    <a:p>
                      <a:pPr marL="228600" marR="0" lvl="0" indent="-22860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AutoNum type="alphaLcPeriod"/>
                        <a:tabLst/>
                        <a:defRPr/>
                      </a:pPr>
                      <a:r>
                        <a:rPr lang="en-US" sz="1050" dirty="0"/>
                        <a:t>AF</a:t>
                      </a:r>
                    </a:p>
                    <a:p>
                      <a:pPr marL="228600" marR="0" lvl="0" indent="-22860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AutoNum type="alphaLcPeriod"/>
                        <a:tabLst/>
                        <a:defRPr/>
                      </a:pPr>
                      <a:r>
                        <a:rPr lang="en-US" sz="1050" dirty="0"/>
                        <a:t>Stroke/TIA</a:t>
                      </a:r>
                    </a:p>
                    <a:p>
                      <a:pPr marL="228600" marR="0" lvl="0" indent="-22860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AutoNum type="alphaLcPeriod"/>
                        <a:tabLst/>
                        <a:defRPr/>
                      </a:pPr>
                      <a:r>
                        <a:rPr lang="en-US" sz="1050" dirty="0"/>
                        <a:t>Hypertension</a:t>
                      </a:r>
                    </a:p>
                    <a:p>
                      <a:pPr marL="228600" marR="0" lvl="0" indent="-22860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AutoNum type="alphaLcPeriod"/>
                        <a:tabLst/>
                        <a:defRPr/>
                      </a:pPr>
                      <a:r>
                        <a:rPr lang="en-US" sz="1050" dirty="0"/>
                        <a:t>DM</a:t>
                      </a:r>
                    </a:p>
                    <a:p>
                      <a:pPr marL="228600" marR="0" lvl="0" indent="-22860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AutoNum type="alphaLcPeriod"/>
                        <a:tabLst/>
                        <a:defRPr/>
                      </a:pPr>
                      <a:r>
                        <a:rPr lang="en-US" sz="1050" dirty="0"/>
                        <a:t>CCF</a:t>
                      </a:r>
                    </a:p>
                    <a:p>
                      <a:pPr marL="228600" marR="0" lvl="0" indent="-22860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AutoNum type="alphaLcPeriod"/>
                        <a:tabLst/>
                        <a:defRPr/>
                      </a:pPr>
                      <a:r>
                        <a:rPr lang="en-US" sz="1050" dirty="0"/>
                        <a:t>Age &gt;75 years </a:t>
                      </a: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i="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itral valve with major risk factors for stroke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i="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aged ball or tilting-disc valve in mitral/aortic position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i="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cent (&lt; 3 </a:t>
                      </a:r>
                      <a:r>
                        <a:rPr lang="en-GB" sz="1050" i="0" kern="1200" baseline="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o</a:t>
                      </a:r>
                      <a:r>
                        <a:rPr lang="en-GB" sz="1050" i="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 stroke or TIA or other high risk stroke situations</a:t>
                      </a:r>
                      <a:endParaRPr lang="en-US" sz="1050" i="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50" dirty="0"/>
                        <a:t>AF</a:t>
                      </a:r>
                    </a:p>
                  </a:txBody>
                  <a:tcP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HA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S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ASc score of 1-4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r CHADS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score of 0-2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(and no prior stroke or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IA)</a:t>
                      </a:r>
                      <a:endParaRPr lang="en-US" sz="105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HA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S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ASc score of 5 or 6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or CHADS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score of 3 or 4</a:t>
                      </a:r>
                      <a:endParaRPr lang="en-US" sz="105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HA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DS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ASc score of ≥7 or CHADS</a:t>
                      </a:r>
                      <a:r>
                        <a:rPr lang="en-GB" sz="1050" kern="1200" baseline="-250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score of 5 or 6</a:t>
                      </a:r>
                    </a:p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cent (&lt; 3 </a:t>
                      </a:r>
                      <a:r>
                        <a:rPr lang="en-GB" sz="1050" kern="1200" baseline="0" dirty="0" err="1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mo</a:t>
                      </a: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) stroke or TIA</a:t>
                      </a:r>
                    </a:p>
                    <a:p>
                      <a:pPr marL="171450" marR="0" lvl="0" indent="-17145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heumatic valvular heart disease</a:t>
                      </a:r>
                      <a:endParaRPr lang="en-US" sz="105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67323"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50" dirty="0"/>
                        <a:t>VTE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>
                        <a:buFont typeface="Arial" panose="020B0604020202020204" pitchFamily="34" charset="0"/>
                        <a:buNone/>
                      </a:pPr>
                      <a:r>
                        <a:rPr lang="en-US" sz="1050" dirty="0"/>
                        <a:t>VTE &gt; 12 m ago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TE (3-12 m)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Recurrent</a:t>
                      </a: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 VTE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ctive cancer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50" dirty="0"/>
                        <a:t>Heterozygous factor V Leiden,</a:t>
                      </a:r>
                      <a:r>
                        <a:rPr lang="en-US" sz="1050" baseline="0" dirty="0"/>
                        <a:t> or </a:t>
                      </a:r>
                      <a:r>
                        <a:rPr lang="en-US" sz="1050" dirty="0"/>
                        <a:t>prothrombin gene mutation)</a:t>
                      </a:r>
                      <a:endParaRPr lang="en-US" sz="105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VTE (&lt;3 m)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rotein C def, protein S def, ATIII def, multiple thrombophilia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ntiphospholipid antibodies</a:t>
                      </a: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GB" sz="1050" kern="1200" baseline="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ctive cancer associated with high VTE risk</a:t>
                      </a:r>
                      <a:endParaRPr lang="en-US" sz="1050" kern="1200" baseline="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65CEE1B-32D4-4623-B03B-7F7F72E547FD}"/>
              </a:ext>
            </a:extLst>
          </p:cNvPr>
          <p:cNvSpPr txBox="1"/>
          <p:nvPr/>
        </p:nvSpPr>
        <p:spPr>
          <a:xfrm>
            <a:off x="3209273" y="9652084"/>
            <a:ext cx="56347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050" b="1" dirty="0"/>
              <a:t>Page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67A3CBE-61B5-4CE7-AF71-6257C61AB3FB}"/>
              </a:ext>
            </a:extLst>
          </p:cNvPr>
          <p:cNvSpPr txBox="1"/>
          <p:nvPr/>
        </p:nvSpPr>
        <p:spPr>
          <a:xfrm>
            <a:off x="249727" y="4637687"/>
            <a:ext cx="5140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800" dirty="0"/>
              <a:t>*not an exhaustive list</a:t>
            </a:r>
          </a:p>
        </p:txBody>
      </p:sp>
    </p:spTree>
    <p:extLst>
      <p:ext uri="{BB962C8B-B14F-4D97-AF65-F5344CB8AC3E}">
        <p14:creationId xmlns:p14="http://schemas.microsoft.com/office/powerpoint/2010/main" val="734740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6B1B676-89DE-4273-820C-F2340F1F1621}"/>
              </a:ext>
            </a:extLst>
          </p:cNvPr>
          <p:cNvSpPr txBox="1"/>
          <p:nvPr/>
        </p:nvSpPr>
        <p:spPr>
          <a:xfrm>
            <a:off x="286911" y="4942387"/>
            <a:ext cx="6283276" cy="1538883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endParaRPr lang="en-US" sz="10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/>
              <a:t>Patients with high thromboembolic risk may not need warfarin interruption when going for minimal or low bleeding risk procedure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/>
              <a:t>Patients  with low or moderate thromboembolic risk may discontinue warfarin without bridging therapy for low or high-risk bleeding procedures 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/>
              <a:t>Bridging therapy is required for patients with high thromboembolic risk going through moderate to high bleeding risk procedure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50" dirty="0"/>
              <a:t>Refer to warfarin guidelines for bridging details</a:t>
            </a:r>
          </a:p>
          <a:p>
            <a:r>
              <a:rPr lang="en-US" sz="1050" dirty="0"/>
              <a:t>                                </a:t>
            </a:r>
            <a:r>
              <a:rPr lang="en-US" sz="1050" b="1" dirty="0"/>
              <a:t>**Does not apply to prosthetic heart valves and please consult cardiology*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D70FFF-DAFB-47EC-B44D-098BFEFBD415}"/>
              </a:ext>
            </a:extLst>
          </p:cNvPr>
          <p:cNvSpPr txBox="1"/>
          <p:nvPr/>
        </p:nvSpPr>
        <p:spPr>
          <a:xfrm>
            <a:off x="2524101" y="4726462"/>
            <a:ext cx="1738230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Warfar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1006747-7B84-4216-972F-AA451EDF6D0B}"/>
              </a:ext>
            </a:extLst>
          </p:cNvPr>
          <p:cNvSpPr txBox="1"/>
          <p:nvPr/>
        </p:nvSpPr>
        <p:spPr>
          <a:xfrm>
            <a:off x="3107303" y="9616371"/>
            <a:ext cx="6424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050" b="1" dirty="0"/>
              <a:t>Page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7AE8D7-55FB-49F3-B650-1900402596B0}"/>
              </a:ext>
            </a:extLst>
          </p:cNvPr>
          <p:cNvSpPr txBox="1"/>
          <p:nvPr/>
        </p:nvSpPr>
        <p:spPr>
          <a:xfrm>
            <a:off x="5265528" y="9472189"/>
            <a:ext cx="15924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Version 1. Jan 2022. </a:t>
            </a:r>
            <a:endParaRPr lang="en-SG" sz="700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EEB010A-4C66-1A5B-8D4A-8FC3EEFBC7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5606303"/>
              </p:ext>
            </p:extLst>
          </p:nvPr>
        </p:nvGraphicFramePr>
        <p:xfrm>
          <a:off x="249276" y="1126317"/>
          <a:ext cx="6358546" cy="155458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99752">
                  <a:extLst>
                    <a:ext uri="{9D8B030D-6E8A-4147-A177-3AD203B41FA5}">
                      <a16:colId xmlns:a16="http://schemas.microsoft.com/office/drawing/2014/main" val="218817536"/>
                    </a:ext>
                  </a:extLst>
                </a:gridCol>
                <a:gridCol w="119190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606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014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0481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37042">
                <a:tc gridSpan="5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Table 3. Bridge or not to bridge</a:t>
                      </a:r>
                    </a:p>
                  </a:txBody>
                  <a:tcPr>
                    <a:solidFill>
                      <a:schemeClr val="accent5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SG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769420"/>
                  </a:ext>
                </a:extLst>
              </a:tr>
              <a:tr h="237042">
                <a:tc gridSpan="2">
                  <a:txBody>
                    <a:bodyPr/>
                    <a:lstStyle/>
                    <a:p>
                      <a:r>
                        <a:rPr lang="en-GB" sz="1050" dirty="0">
                          <a:solidFill>
                            <a:schemeClr val="tx1"/>
                          </a:solidFill>
                        </a:rPr>
                        <a:t>Thrombotic</a:t>
                      </a:r>
                      <a:r>
                        <a:rPr lang="en-GB" sz="1050" baseline="0" dirty="0">
                          <a:solidFill>
                            <a:schemeClr val="tx1"/>
                          </a:solidFill>
                        </a:rPr>
                        <a:t> risk</a:t>
                      </a:r>
                      <a:endParaRPr lang="en-GB" sz="105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solidFill>
                            <a:schemeClr val="tx1"/>
                          </a:solidFill>
                        </a:rPr>
                        <a:t>Low</a:t>
                      </a:r>
                      <a:endParaRPr lang="en-GB" sz="105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solidFill>
                            <a:schemeClr val="tx1"/>
                          </a:solidFill>
                        </a:rPr>
                        <a:t>Moderate</a:t>
                      </a:r>
                      <a:endParaRPr lang="en-GB" sz="105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>
                          <a:solidFill>
                            <a:schemeClr val="tx1"/>
                          </a:solidFill>
                        </a:rPr>
                        <a:t>High</a:t>
                      </a:r>
                      <a:endParaRPr lang="en-GB" sz="105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1333">
                <a:tc rowSpan="3">
                  <a:txBody>
                    <a:bodyPr/>
                    <a:lstStyle/>
                    <a:p>
                      <a:r>
                        <a:rPr lang="en-GB" sz="1050" dirty="0">
                          <a:solidFill>
                            <a:schemeClr val="tx1"/>
                          </a:solidFill>
                        </a:rPr>
                        <a:t>Procedural bleeding</a:t>
                      </a:r>
                      <a:r>
                        <a:rPr lang="en-GB" sz="1050" baseline="0" dirty="0">
                          <a:solidFill>
                            <a:schemeClr val="tx1"/>
                          </a:solidFill>
                        </a:rPr>
                        <a:t> risk</a:t>
                      </a:r>
                      <a:endParaRPr lang="en-GB" sz="105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b="1" dirty="0"/>
                        <a:t>Minimal</a:t>
                      </a:r>
                      <a:endParaRPr lang="en-GB" sz="1050" b="1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Stop</a:t>
                      </a:r>
                      <a:r>
                        <a:rPr lang="en-US" sz="1050" baseline="0" dirty="0"/>
                        <a:t> or continue anticoagulation</a:t>
                      </a:r>
                      <a:endParaRPr lang="en-GB" sz="1050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; No bridge</a:t>
                      </a:r>
                      <a:endParaRPr lang="en-GB" sz="1050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Continue anticoagulation</a:t>
                      </a:r>
                      <a:endParaRPr lang="en-GB" sz="1050" dirty="0"/>
                    </a:p>
                  </a:txBody>
                  <a:tcPr>
                    <a:solidFill>
                      <a:schemeClr val="accent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0091">
                <a:tc v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b="1" dirty="0"/>
                        <a:t>Low</a:t>
                      </a:r>
                      <a:endParaRPr lang="en-GB" sz="1050" b="1" dirty="0"/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; No bridge</a:t>
                      </a:r>
                      <a:endParaRPr lang="en-GB" sz="1050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; No bridge</a:t>
                      </a:r>
                      <a:endParaRPr lang="en-GB" sz="1050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 &amp; bridge</a:t>
                      </a:r>
                      <a:endParaRPr lang="en-GB" sz="1050" dirty="0"/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0091">
                <a:tc v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b="1" dirty="0"/>
                        <a:t>High</a:t>
                      </a:r>
                      <a:endParaRPr lang="en-GB" sz="1050" b="1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; No bridge</a:t>
                      </a:r>
                      <a:endParaRPr lang="en-GB" sz="1050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; No bridge</a:t>
                      </a:r>
                      <a:endParaRPr lang="en-GB" sz="1050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Stop &amp; consider bridge</a:t>
                      </a:r>
                      <a:endParaRPr lang="en-GB" sz="105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936A5373-6243-15A0-15F6-2DD657FF00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1005921"/>
              </p:ext>
            </p:extLst>
          </p:nvPr>
        </p:nvGraphicFramePr>
        <p:xfrm>
          <a:off x="249728" y="6769049"/>
          <a:ext cx="6358544" cy="1645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4818">
                  <a:extLst>
                    <a:ext uri="{9D8B030D-6E8A-4147-A177-3AD203B41FA5}">
                      <a16:colId xmlns:a16="http://schemas.microsoft.com/office/drawing/2014/main" val="2082367188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2936034526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3038019191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202432977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915721752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3297176301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3657345741"/>
                    </a:ext>
                  </a:extLst>
                </a:gridCol>
                <a:gridCol w="794818">
                  <a:extLst>
                    <a:ext uri="{9D8B030D-6E8A-4147-A177-3AD203B41FA5}">
                      <a16:colId xmlns:a16="http://schemas.microsoft.com/office/drawing/2014/main" val="324459209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SG" sz="105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-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-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-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-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-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-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/>
                        <a:t>Day of surgery</a:t>
                      </a:r>
                      <a:endParaRPr lang="en-SG" sz="105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62823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SG" sz="1050" dirty="0"/>
                        <a:t>Warfari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Take last dos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05922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SG" sz="1050" dirty="0"/>
                        <a:t>INR tes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Check IN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Day -1 or day of surgery check INR&lt;1.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83470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SG" sz="1050" dirty="0"/>
                        <a:t>LMWH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>
                          <a:solidFill>
                            <a:schemeClr val="tx1"/>
                          </a:solidFill>
                        </a:rPr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SG" sz="1050" dirty="0">
                          <a:solidFill>
                            <a:schemeClr val="tx1"/>
                          </a:solidFill>
                        </a:rPr>
                        <a:t>X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Commence LMWH when INR &lt;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SG" sz="1050" dirty="0"/>
                        <a:t>Stop LMWH 24 hours before surger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SG" sz="105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68742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7146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8C469F2-6CBD-E8AC-9392-FD61F2749E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6326" y="83149"/>
            <a:ext cx="845735" cy="410053"/>
          </a:xfrm>
          <a:prstGeom prst="rect">
            <a:avLst/>
          </a:prstGeom>
        </p:spPr>
      </p:pic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49A1210-6572-66F5-377E-B956054661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8026"/>
              </p:ext>
            </p:extLst>
          </p:nvPr>
        </p:nvGraphicFramePr>
        <p:xfrm>
          <a:off x="344914" y="1859528"/>
          <a:ext cx="6283277" cy="30861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9226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81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482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179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124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8409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0472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291520">
                <a:tc gridSpan="8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Table 4. </a:t>
                      </a:r>
                      <a:r>
                        <a:rPr lang="en-US" sz="1050" dirty="0"/>
                        <a:t>DOAC interruption before a surgery/procedure. Dark blue area indicates no DOAC taken on those days</a:t>
                      </a:r>
                      <a:endParaRPr lang="en-US" sz="1050" b="1" kern="1200" dirty="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700" b="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700" b="0" dirty="0"/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700" b="0" dirty="0"/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r>
                        <a:rPr lang="en-US" sz="1050" b="0" dirty="0"/>
                        <a:t>DOACs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sz="1050" b="0" dirty="0"/>
                        <a:t>Surgery/</a:t>
                      </a:r>
                    </a:p>
                    <a:p>
                      <a:r>
                        <a:rPr lang="en-US" sz="1050" b="0" dirty="0"/>
                        <a:t>Procedure</a:t>
                      </a:r>
                      <a:r>
                        <a:rPr lang="en-US" sz="1050" b="0" baseline="0" dirty="0"/>
                        <a:t> bleeding risk</a:t>
                      </a:r>
                      <a:endParaRPr lang="en-US" sz="1050" b="0" dirty="0"/>
                    </a:p>
                  </a:txBody>
                  <a:tcPr>
                    <a:noFill/>
                  </a:tcPr>
                </a:tc>
                <a:tc gridSpan="5">
                  <a:txBody>
                    <a:bodyPr/>
                    <a:lstStyle/>
                    <a:p>
                      <a:r>
                        <a:rPr lang="en-US" sz="1050" b="0" dirty="0"/>
                        <a:t>Pre-procedural interruption of DOAC (days)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dirty="0"/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800" dirty="0"/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800" dirty="0"/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800" dirty="0"/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dirty="0"/>
                        <a:t>Day of the procedure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-5</a:t>
                      </a:r>
                    </a:p>
                  </a:txBody>
                  <a:tcPr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-4</a:t>
                      </a:r>
                    </a:p>
                  </a:txBody>
                  <a:tcPr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-3</a:t>
                      </a:r>
                    </a:p>
                  </a:txBody>
                  <a:tcPr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-2</a:t>
                      </a:r>
                    </a:p>
                  </a:txBody>
                  <a:tcPr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-1</a:t>
                      </a:r>
                    </a:p>
                  </a:txBody>
                  <a:tcPr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r>
                        <a:rPr lang="en-US" sz="1050" dirty="0"/>
                        <a:t>Dabigatran</a:t>
                      </a:r>
                    </a:p>
                    <a:p>
                      <a:r>
                        <a:rPr lang="en-US" sz="1050" dirty="0"/>
                        <a:t>(CrCl≥50ml/min)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High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002060"/>
                    </a:solidFill>
                  </a:tcPr>
                </a:tc>
                <a:tc rowSpan="8"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9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Minimal/Low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r>
                        <a:rPr lang="en-US" sz="1050" dirty="0"/>
                        <a:t>Dabigatran</a:t>
                      </a:r>
                    </a:p>
                    <a:p>
                      <a:r>
                        <a:rPr lang="en-US" sz="1050" dirty="0"/>
                        <a:t>(</a:t>
                      </a:r>
                      <a:r>
                        <a:rPr lang="en-US" sz="1050" dirty="0" err="1"/>
                        <a:t>CrCl</a:t>
                      </a:r>
                      <a:r>
                        <a:rPr lang="en-US" sz="1050" dirty="0"/>
                        <a:t>&lt;50ml/min)*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dirty="0"/>
                        <a:t>High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Minimal/Low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r>
                        <a:rPr lang="en-US" sz="1050" dirty="0"/>
                        <a:t>Rivaroxaban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(CrCl≥30ml/min)*</a:t>
                      </a:r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High</a:t>
                      </a:r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Minimal/Low</a:t>
                      </a:r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33CCC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r>
                        <a:rPr lang="en-US" sz="1050" dirty="0"/>
                        <a:t>Apixaban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(CrCl≥30ml/min)*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High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/>
                        <a:t>Minimal/Low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05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7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637C49F-B2B9-79F4-720F-4F8AD0DFD6EF}"/>
              </a:ext>
            </a:extLst>
          </p:cNvPr>
          <p:cNvSpPr txBox="1"/>
          <p:nvPr/>
        </p:nvSpPr>
        <p:spPr>
          <a:xfrm>
            <a:off x="344913" y="4957220"/>
            <a:ext cx="6278911" cy="577081"/>
          </a:xfrm>
          <a:prstGeom prst="rect">
            <a:avLst/>
          </a:prstGeom>
          <a:solidFill>
            <a:srgbClr val="FFFF99"/>
          </a:solidFill>
        </p:spPr>
        <p:txBody>
          <a:bodyPr wrap="square" rtlCol="0">
            <a:spAutoFit/>
          </a:bodyPr>
          <a:lstStyle/>
          <a:p>
            <a:r>
              <a:rPr lang="en-GB" sz="1050" dirty="0"/>
              <a:t>*DOAC can be resumed ~24 hours after low/moderate-bleed-risk procedures, and 48-72 hours after high-bleed-risk procedures. In selected patients at high risk for VTE, low-dose anticoagulants (i.e., enoxaparin, 40 mg daily) can be given for the first 48-72 hours post-procedure</a:t>
            </a:r>
            <a:endParaRPr lang="en-US" sz="1050" dirty="0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10848064-9038-C685-A028-1C1328717F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6029881"/>
              </p:ext>
            </p:extLst>
          </p:nvPr>
        </p:nvGraphicFramePr>
        <p:xfrm>
          <a:off x="344913" y="7882790"/>
          <a:ext cx="6278911" cy="1005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382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694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7122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3680">
                <a:tc gridSpan="3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Table 5. Time interval for discontinuation of antiplatelet agents prior to procedure (if required) </a:t>
                      </a:r>
                    </a:p>
                  </a:txBody>
                  <a:tcPr>
                    <a:solidFill>
                      <a:schemeClr val="accent5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b="0" kern="1200"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Antiplatelets</a:t>
                      </a:r>
                    </a:p>
                  </a:txBody>
                  <a:tcP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When to cease antiplatelet therapy</a:t>
                      </a:r>
                    </a:p>
                  </a:txBody>
                  <a:tcP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When to restart </a:t>
                      </a:r>
                    </a:p>
                  </a:txBody>
                  <a:tcPr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spirin, </a:t>
                      </a:r>
                      <a:r>
                        <a:rPr lang="en-US" sz="105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asugrel</a:t>
                      </a:r>
                      <a:endParaRPr lang="en-US" sz="105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t least 7 days prior</a:t>
                      </a: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sz="105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ntiplatelets</a:t>
                      </a:r>
                      <a:r>
                        <a:rPr lang="en-US" sz="105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should be restarted as soon as possible</a:t>
                      </a:r>
                      <a:r>
                        <a:rPr lang="en-US" sz="105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once </a:t>
                      </a:r>
                      <a:r>
                        <a:rPr lang="en-US" sz="1050" kern="1200" baseline="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haemostasis</a:t>
                      </a:r>
                      <a:r>
                        <a:rPr lang="en-US" sz="1050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is achieved.</a:t>
                      </a:r>
                      <a:endParaRPr lang="en-US" sz="105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solidFill>
                      <a:srgbClr val="CCC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05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Clopidogrel, </a:t>
                      </a:r>
                      <a:r>
                        <a:rPr lang="en-US" sz="1050" b="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icagrelor</a:t>
                      </a:r>
                      <a:endParaRPr lang="en-US" sz="1050" b="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l" defTabSz="685800" rtl="0" eaLnBrk="1" latinLnBrk="0" hangingPunct="1"/>
                      <a:r>
                        <a:rPr lang="en-US" sz="1050" b="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t least 5 days prior</a:t>
                      </a: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algn="l" defTabSz="685800" rtl="0" eaLnBrk="1" latinLnBrk="0" hangingPunct="1"/>
                      <a:endParaRPr lang="en-US" sz="700" b="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F4C138D-602A-C9A9-EC1C-56CFFE1774EF}"/>
              </a:ext>
            </a:extLst>
          </p:cNvPr>
          <p:cNvSpPr txBox="1"/>
          <p:nvPr/>
        </p:nvSpPr>
        <p:spPr>
          <a:xfrm>
            <a:off x="344913" y="1103949"/>
            <a:ext cx="6278911" cy="738664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GB" sz="105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/>
              <a:t>Stopping of dabigatran, apixaban and rivaroxaban therapy for selected minimal or low bleeding risk procedures may not be neede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/>
              <a:t>Bridging therapy is not required for patients receiving DOAC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189EE9-D98C-5C07-7F96-98EE1D9AACE7}"/>
              </a:ext>
            </a:extLst>
          </p:cNvPr>
          <p:cNvSpPr txBox="1"/>
          <p:nvPr/>
        </p:nvSpPr>
        <p:spPr>
          <a:xfrm>
            <a:off x="2557151" y="863303"/>
            <a:ext cx="1743697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OAC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4A0A22-3D0C-81DF-1B3D-B6174C6C51F9}"/>
              </a:ext>
            </a:extLst>
          </p:cNvPr>
          <p:cNvSpPr txBox="1"/>
          <p:nvPr/>
        </p:nvSpPr>
        <p:spPr>
          <a:xfrm>
            <a:off x="344914" y="6463321"/>
            <a:ext cx="6278911" cy="137730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endParaRPr lang="en-US" sz="10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/>
              <a:t>Antiplatelet is key to the secondary prevention of cardiovascular disease, particularly in the use of clopidogrel in ischaemic strokes and dual antiplatelet therapy (DAPT) in AC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/>
              <a:t>Increased risk of bleeding associated with antiplatelet use has to be balanced with its clinical benefits with advice should be sought from multidisciplinary team including surgeons and prescribing physicians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/>
              <a:t>Should the risk of bleeding outweighs the benefits, and antiplatelet agents are to be ceased, they should be ceased according to the timeframes outlined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1050" dirty="0"/>
              <a:t>In most circumstances, aspirin need not be stopped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8792919-8A43-675D-A5BC-FBA39F9CCC7E}"/>
              </a:ext>
            </a:extLst>
          </p:cNvPr>
          <p:cNvSpPr txBox="1"/>
          <p:nvPr/>
        </p:nvSpPr>
        <p:spPr>
          <a:xfrm>
            <a:off x="2617441" y="6270877"/>
            <a:ext cx="1738230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ntiplatelet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7A8DC8-60B4-AC8B-1AB8-44F64D438AFD}"/>
              </a:ext>
            </a:extLst>
          </p:cNvPr>
          <p:cNvSpPr txBox="1"/>
          <p:nvPr/>
        </p:nvSpPr>
        <p:spPr>
          <a:xfrm>
            <a:off x="3107303" y="9616371"/>
            <a:ext cx="6424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050" b="1" dirty="0"/>
              <a:t>Page 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AD87C1-EFD5-D49A-27A2-26999D7A0F8F}"/>
              </a:ext>
            </a:extLst>
          </p:cNvPr>
          <p:cNvSpPr txBox="1"/>
          <p:nvPr/>
        </p:nvSpPr>
        <p:spPr>
          <a:xfrm>
            <a:off x="287361" y="9294856"/>
            <a:ext cx="594787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SG" sz="800" dirty="0" err="1"/>
              <a:t>Douketis</a:t>
            </a:r>
            <a:r>
              <a:rPr lang="en-SG" sz="800" dirty="0"/>
              <a:t> J et al.  Executive Summary: Perioperative Management of Antithrombotic Therapy: An American College of Chest Physicians Clinical Practice Guideline. Chest. 2022 Nov;162(5):1127-1139</a:t>
            </a:r>
          </a:p>
        </p:txBody>
      </p:sp>
    </p:spTree>
    <p:extLst>
      <p:ext uri="{BB962C8B-B14F-4D97-AF65-F5344CB8AC3E}">
        <p14:creationId xmlns:p14="http://schemas.microsoft.com/office/powerpoint/2010/main" val="25443351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4107" y="285267"/>
            <a:ext cx="62968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Interruption of anti-</a:t>
            </a:r>
            <a:r>
              <a:rPr lang="en-US" sz="1600" b="1" dirty="0" err="1"/>
              <a:t>thrombotics</a:t>
            </a:r>
            <a:r>
              <a:rPr lang="en-US" sz="1600" b="1" dirty="0"/>
              <a:t> for lumbar puncture (LP)</a:t>
            </a:r>
            <a:endParaRPr lang="en-SG" sz="1600" b="1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0666294"/>
              </p:ext>
            </p:extLst>
          </p:nvPr>
        </p:nvGraphicFramePr>
        <p:xfrm>
          <a:off x="258269" y="779589"/>
          <a:ext cx="6295856" cy="4206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147928">
                  <a:extLst>
                    <a:ext uri="{9D8B030D-6E8A-4147-A177-3AD203B41FA5}">
                      <a16:colId xmlns:a16="http://schemas.microsoft.com/office/drawing/2014/main" val="1126005169"/>
                    </a:ext>
                  </a:extLst>
                </a:gridCol>
                <a:gridCol w="3147928">
                  <a:extLst>
                    <a:ext uri="{9D8B030D-6E8A-4147-A177-3AD203B41FA5}">
                      <a16:colId xmlns:a16="http://schemas.microsoft.com/office/drawing/2014/main" val="4116455272"/>
                    </a:ext>
                  </a:extLst>
                </a:gridCol>
              </a:tblGrid>
              <a:tr h="172156"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nsider 'thrombosis Risk</a:t>
                      </a:r>
                      <a:endParaRPr lang="en-SG" sz="1200" dirty="0"/>
                    </a:p>
                  </a:txBody>
                  <a:tcPr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SG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058005"/>
                  </a:ext>
                </a:extLst>
              </a:tr>
              <a:tr h="201251"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spending antithrombotic treatment comes with</a:t>
                      </a:r>
                      <a:r>
                        <a:rPr lang="en-US" sz="12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n increased risk of thrombosis</a:t>
                      </a:r>
                      <a:endParaRPr lang="en-SG" sz="1200" dirty="0"/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SG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2472596"/>
                  </a:ext>
                </a:extLst>
              </a:tr>
              <a:tr h="136827">
                <a:tc>
                  <a:txBody>
                    <a:bodyPr/>
                    <a:lstStyle/>
                    <a:p>
                      <a:r>
                        <a:rPr lang="en-US" sz="1200" b="1" baseline="0" dirty="0"/>
                        <a:t>Warfarin and DOACs</a:t>
                      </a:r>
                      <a:endParaRPr lang="en-SG" sz="1200" b="1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nti-platelet</a:t>
                      </a:r>
                      <a:r>
                        <a:rPr lang="en-US" sz="1200" b="1" baseline="0" dirty="0"/>
                        <a:t> agents</a:t>
                      </a:r>
                      <a:endParaRPr lang="en-SG" sz="1200" b="1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8881026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R</a:t>
                      </a:r>
                      <a:r>
                        <a:rPr lang="en-US" sz="1200" baseline="0" dirty="0"/>
                        <a:t>efer to </a:t>
                      </a:r>
                      <a:r>
                        <a:rPr lang="en-US" sz="1200" b="1" baseline="0" dirty="0"/>
                        <a:t>table 3 </a:t>
                      </a:r>
                      <a:r>
                        <a:rPr lang="en-US" sz="1200" baseline="0" dirty="0"/>
                        <a:t>and </a:t>
                      </a:r>
                      <a:r>
                        <a:rPr lang="en-US" sz="1200" b="1" baseline="0" dirty="0"/>
                        <a:t>table 4 </a:t>
                      </a:r>
                      <a:r>
                        <a:rPr lang="en-US" sz="1200" b="0" baseline="0" dirty="0"/>
                        <a:t>for need of bridging and interruption durations</a:t>
                      </a:r>
                      <a:endParaRPr lang="en-SG" sz="1200" b="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High risk of thrombosis</a:t>
                      </a:r>
                    </a:p>
                    <a:p>
                      <a:r>
                        <a:rPr lang="en-US" sz="1200" dirty="0"/>
                        <a:t>Drug eluting stents&lt;12</a:t>
                      </a:r>
                      <a:r>
                        <a:rPr lang="en-US" sz="1200" baseline="0" dirty="0"/>
                        <a:t> months or bare metal stents&lt;1month</a:t>
                      </a:r>
                    </a:p>
                    <a:p>
                      <a:endParaRPr lang="en-US" sz="1200" baseline="0" dirty="0"/>
                    </a:p>
                    <a:p>
                      <a:r>
                        <a:rPr lang="en-US" sz="1200" baseline="0" dirty="0"/>
                        <a:t>→ Consider postponing</a:t>
                      </a:r>
                      <a:endParaRPr lang="en-SG" sz="1200" dirty="0"/>
                    </a:p>
                  </a:txBody>
                  <a:tcP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2350650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SG" sz="1050" b="1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baseline="0" dirty="0"/>
                        <a:t>Intermediate risk of thrombosis</a:t>
                      </a:r>
                    </a:p>
                    <a:p>
                      <a:r>
                        <a:rPr lang="en-US" sz="1200" baseline="0" dirty="0"/>
                        <a:t>On dual anti-platelet agent</a:t>
                      </a:r>
                    </a:p>
                    <a:p>
                      <a:endParaRPr lang="en-US" sz="1200" baseline="0" dirty="0"/>
                    </a:p>
                    <a:p>
                      <a:r>
                        <a:rPr lang="en-US" sz="1200" baseline="0" dirty="0"/>
                        <a:t>→ Consider </a:t>
                      </a:r>
                      <a:r>
                        <a:rPr lang="en-US" sz="1200" baseline="0"/>
                        <a:t>aspirin single agent </a:t>
                      </a:r>
                      <a:r>
                        <a:rPr lang="en-US" sz="1200" baseline="0" dirty="0"/>
                        <a:t>after discussion with relevant specialist</a:t>
                      </a:r>
                      <a:endParaRPr lang="en-SG" sz="1200" dirty="0"/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6622019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LMWH (prophylaxis dose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/>
                        <a:t>Stop for at least </a:t>
                      </a:r>
                      <a:r>
                        <a:rPr lang="en-US" sz="1200" b="1" dirty="0"/>
                        <a:t>12</a:t>
                      </a:r>
                      <a:r>
                        <a:rPr lang="en-US" sz="1200" b="0" dirty="0"/>
                        <a:t> hours prior to LP</a:t>
                      </a:r>
                      <a:endParaRPr lang="en-SG" sz="1200" b="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SG" sz="1050" dirty="0"/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8703183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LMWH (treatment dose)</a:t>
                      </a:r>
                      <a:endParaRPr lang="en-SG" sz="1200" b="1" dirty="0"/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/>
                        <a:t>Stop for at least </a:t>
                      </a:r>
                      <a:r>
                        <a:rPr lang="en-US" sz="1200" b="1" dirty="0"/>
                        <a:t>24</a:t>
                      </a:r>
                      <a:r>
                        <a:rPr lang="en-US" sz="1200" b="0" dirty="0"/>
                        <a:t> hours prior</a:t>
                      </a:r>
                      <a:r>
                        <a:rPr lang="en-US" sz="1200" b="0" baseline="0" dirty="0"/>
                        <a:t> to LP</a:t>
                      </a:r>
                      <a:endParaRPr lang="en-SG" sz="1200" b="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SG" sz="1050" dirty="0"/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6191674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Unfractionated</a:t>
                      </a:r>
                      <a:r>
                        <a:rPr lang="en-US" sz="1200" b="1" baseline="0" dirty="0"/>
                        <a:t> heparin</a:t>
                      </a:r>
                      <a:endParaRPr lang="en-SG" sz="1200" b="1" dirty="0"/>
                    </a:p>
                    <a:p>
                      <a:r>
                        <a:rPr lang="en-US" sz="1200" dirty="0"/>
                        <a:t>Stop</a:t>
                      </a:r>
                      <a:r>
                        <a:rPr lang="en-US" sz="1200" baseline="0" dirty="0"/>
                        <a:t> for</a:t>
                      </a:r>
                      <a:r>
                        <a:rPr lang="en-US" sz="1200" b="1" baseline="0" dirty="0"/>
                        <a:t> 4 </a:t>
                      </a:r>
                      <a:r>
                        <a:rPr lang="en-US" sz="1200" baseline="0" dirty="0"/>
                        <a:t>hours prior to LP</a:t>
                      </a:r>
                      <a:endParaRPr lang="en-SG" sz="1200" b="1" dirty="0"/>
                    </a:p>
                  </a:txBody>
                  <a:tcP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SG" sz="1050" dirty="0"/>
                    </a:p>
                  </a:txBody>
                  <a:tcP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32626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58269" y="5141597"/>
            <a:ext cx="6295856" cy="646331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Urgent LP</a:t>
            </a:r>
            <a:r>
              <a:rPr lang="en-US" sz="1200" dirty="0">
                <a:solidFill>
                  <a:schemeClr val="bg1"/>
                </a:solidFill>
              </a:rPr>
              <a:t>: Discuss with </a:t>
            </a:r>
            <a:r>
              <a:rPr lang="en-US" sz="1200" dirty="0" err="1">
                <a:solidFill>
                  <a:schemeClr val="bg1"/>
                </a:solidFill>
              </a:rPr>
              <a:t>haematologist</a:t>
            </a:r>
            <a:r>
              <a:rPr lang="en-US" sz="1200" dirty="0">
                <a:solidFill>
                  <a:schemeClr val="bg1"/>
                </a:solidFill>
              </a:rPr>
              <a:t> with regards to urgent reversal of warfarin or DOAC. If the benefit of the LP outweighs the risk of bleeding, patient should be informed and post-procedural carefully monitored for new neurological symptoms or signs.  </a:t>
            </a:r>
            <a:endParaRPr lang="en-SG" sz="1200" dirty="0">
              <a:solidFill>
                <a:schemeClr val="bg1"/>
              </a:solidFill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1426242"/>
              </p:ext>
            </p:extLst>
          </p:nvPr>
        </p:nvGraphicFramePr>
        <p:xfrm>
          <a:off x="280621" y="5943696"/>
          <a:ext cx="6295856" cy="3200400"/>
        </p:xfrm>
        <a:graphic>
          <a:graphicData uri="http://schemas.openxmlformats.org/drawingml/2006/table">
            <a:tbl>
              <a:tblPr firstRow="1" bandRow="1">
                <a:tableStyleId>{46F890A9-2807-4EBB-B81D-B2AA78EC7F39}</a:tableStyleId>
              </a:tblPr>
              <a:tblGrid>
                <a:gridCol w="6295856">
                  <a:extLst>
                    <a:ext uri="{9D8B030D-6E8A-4147-A177-3AD203B41FA5}">
                      <a16:colId xmlns:a16="http://schemas.microsoft.com/office/drawing/2014/main" val="1126005169"/>
                    </a:ext>
                  </a:extLst>
                </a:gridCol>
              </a:tblGrid>
              <a:tr h="17215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effectLst/>
                        </a:rPr>
                        <a:t>Restarting </a:t>
                      </a:r>
                      <a:r>
                        <a:rPr lang="en-US" sz="1200" kern="1200" dirty="0" err="1">
                          <a:effectLst/>
                        </a:rPr>
                        <a:t>antithrombotics</a:t>
                      </a:r>
                      <a:r>
                        <a:rPr lang="en-US" sz="1200" kern="1200" dirty="0">
                          <a:effectLst/>
                        </a:rPr>
                        <a:t> post LP</a:t>
                      </a:r>
                      <a:endParaRPr lang="en-SG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058005"/>
                  </a:ext>
                </a:extLst>
              </a:tr>
              <a:tr h="389211">
                <a:tc>
                  <a:txBody>
                    <a:bodyPr/>
                    <a:lstStyle/>
                    <a:p>
                      <a:r>
                        <a:rPr lang="en-US" sz="1200" b="1" baseline="0" dirty="0"/>
                        <a:t>Warfarin</a:t>
                      </a:r>
                      <a:endParaRPr lang="en-SG" sz="1200" b="1" dirty="0"/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12 hours after LP</a:t>
                      </a:r>
                      <a:endParaRPr lang="en-SG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188810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DOACs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6 hours after LP</a:t>
                      </a:r>
                      <a:endParaRPr 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79930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LMWH</a:t>
                      </a:r>
                      <a:r>
                        <a:rPr lang="en-US" sz="1200" b="1" baseline="0" dirty="0"/>
                        <a:t> (prophylaxis dose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aseline="0" dirty="0"/>
                        <a:t>4 hours</a:t>
                      </a:r>
                      <a:endParaRPr 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893292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LMWH (treatment dose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4</a:t>
                      </a:r>
                      <a:r>
                        <a:rPr lang="en-US" sz="1200" baseline="0" dirty="0"/>
                        <a:t> hours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aseline="0" dirty="0"/>
                        <a:t>24 hours </a:t>
                      </a:r>
                      <a:r>
                        <a:rPr lang="en-US" sz="1200" i="1" baseline="0" dirty="0"/>
                        <a:t>if traumatic</a:t>
                      </a:r>
                      <a:endParaRPr lang="en-SG" sz="1200" b="1" i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35640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Unfractionated</a:t>
                      </a:r>
                      <a:r>
                        <a:rPr lang="en-US" sz="1200" b="1" baseline="0" dirty="0"/>
                        <a:t> heparin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1 hour after</a:t>
                      </a:r>
                      <a:r>
                        <a:rPr lang="en-US" sz="1200" baseline="0" dirty="0"/>
                        <a:t> LP</a:t>
                      </a:r>
                      <a:endParaRPr lang="en-SG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26049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Anti-platelet</a:t>
                      </a:r>
                      <a:r>
                        <a:rPr lang="en-US" sz="1200" b="1" baseline="0" dirty="0"/>
                        <a:t> agents</a:t>
                      </a:r>
                      <a:endParaRPr lang="en-SG" sz="1200" b="1" dirty="0"/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6 hours after LP</a:t>
                      </a:r>
                      <a:endParaRPr lang="en-SG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417946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1006747-7B84-4216-972F-AA451EDF6D0B}"/>
              </a:ext>
            </a:extLst>
          </p:cNvPr>
          <p:cNvSpPr txBox="1"/>
          <p:nvPr/>
        </p:nvSpPr>
        <p:spPr>
          <a:xfrm>
            <a:off x="3107303" y="9616371"/>
            <a:ext cx="6424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050" b="1" dirty="0"/>
              <a:t>Page 4</a:t>
            </a: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839929"/>
              </p:ext>
            </p:extLst>
          </p:nvPr>
        </p:nvGraphicFramePr>
        <p:xfrm>
          <a:off x="120241" y="9093703"/>
          <a:ext cx="6217389" cy="411480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6217389">
                  <a:extLst>
                    <a:ext uri="{9D8B030D-6E8A-4147-A177-3AD203B41FA5}">
                      <a16:colId xmlns:a16="http://schemas.microsoft.com/office/drawing/2014/main" val="2718560737"/>
                    </a:ext>
                  </a:extLst>
                </a:gridCol>
              </a:tblGrid>
              <a:tr h="187437">
                <a:tc>
                  <a:txBody>
                    <a:bodyPr/>
                    <a:lstStyle/>
                    <a:p>
                      <a:r>
                        <a:rPr lang="en-SG" sz="1050" b="0" dirty="0">
                          <a:solidFill>
                            <a:schemeClr val="tx1"/>
                          </a:solidFill>
                        </a:rPr>
                        <a:t>Recommendations</a:t>
                      </a:r>
                      <a:r>
                        <a:rPr lang="en-SG" sz="1050" b="0" baseline="0" dirty="0">
                          <a:solidFill>
                            <a:schemeClr val="tx1"/>
                          </a:solidFill>
                        </a:rPr>
                        <a:t> based on Dodd KC et al. </a:t>
                      </a:r>
                      <a:r>
                        <a:rPr lang="en-SG" sz="1050" b="0" baseline="0" dirty="0" err="1">
                          <a:solidFill>
                            <a:schemeClr val="tx1"/>
                          </a:solidFill>
                        </a:rPr>
                        <a:t>Periprocedural</a:t>
                      </a:r>
                      <a:r>
                        <a:rPr lang="en-SG" sz="1050" b="0" baseline="0" dirty="0">
                          <a:solidFill>
                            <a:schemeClr val="tx1"/>
                          </a:solidFill>
                        </a:rPr>
                        <a:t> antithrombotic management for lumbar puncture: Association of British Neurologists clinical guideline Practical Neurology 2018;18:436-446.  </a:t>
                      </a:r>
                      <a:endParaRPr lang="en-SG" sz="105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1783592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75DF413C-F106-4FBF-BEB6-1EF5C1787D8C}"/>
              </a:ext>
            </a:extLst>
          </p:cNvPr>
          <p:cNvSpPr txBox="1"/>
          <p:nvPr/>
        </p:nvSpPr>
        <p:spPr>
          <a:xfrm>
            <a:off x="5265528" y="9472189"/>
            <a:ext cx="15924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Version 1. Jan 2022. </a:t>
            </a:r>
            <a:endParaRPr lang="en-SG" sz="700" dirty="0"/>
          </a:p>
        </p:txBody>
      </p:sp>
    </p:spTree>
    <p:extLst>
      <p:ext uri="{BB962C8B-B14F-4D97-AF65-F5344CB8AC3E}">
        <p14:creationId xmlns:p14="http://schemas.microsoft.com/office/powerpoint/2010/main" val="1559534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61</TotalTime>
  <Words>1250</Words>
  <Application>Microsoft Office PowerPoint</Application>
  <PresentationFormat>A4 Paper (210x297 mm)</PresentationFormat>
  <Paragraphs>21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eri‐operative management of anticoagulation and antiplatelet therapy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ticoagulation for Venous Thromboembolism</dc:title>
  <dc:creator>Yap Eng Soo</dc:creator>
  <cp:lastModifiedBy>Eng Soo Yap</cp:lastModifiedBy>
  <cp:revision>108</cp:revision>
  <cp:lastPrinted>2021-11-19T02:40:36Z</cp:lastPrinted>
  <dcterms:created xsi:type="dcterms:W3CDTF">2019-03-06T23:34:29Z</dcterms:created>
  <dcterms:modified xsi:type="dcterms:W3CDTF">2026-03-15T14:24:56Z</dcterms:modified>
</cp:coreProperties>
</file>